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56" r:id="rId3"/>
    <p:sldId id="259" r:id="rId4"/>
    <p:sldId id="258" r:id="rId5"/>
    <p:sldId id="260" r:id="rId6"/>
    <p:sldId id="261" r:id="rId7"/>
    <p:sldId id="262" r:id="rId8"/>
    <p:sldId id="263" r:id="rId9"/>
    <p:sldId id="269" r:id="rId10"/>
    <p:sldId id="267" r:id="rId11"/>
    <p:sldId id="268" r:id="rId12"/>
    <p:sldId id="266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90" d="100"/>
          <a:sy n="90" d="100"/>
        </p:scale>
        <p:origin x="35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207DD4-1096-2B1F-741A-90B8B098E3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9D54571-FF9A-C692-F5F8-A9D9E828F0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8B4D7E-1D02-688E-44D6-413C6B85E8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A5E03-E4AF-490C-967C-814C2EF2C510}" type="datetimeFigureOut">
              <a:rPr lang="en-US" smtClean="0"/>
              <a:t>6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821D67-5B76-42EF-AFFB-F7A8BAC9C5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03D1A0-08EA-655C-9C34-2D231BD0D5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74560-31AB-4824-97E0-F92999A43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772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C560EC-271E-6CCF-8795-8EE8CF8C85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C481557-973A-C88D-F4EC-D0DB6FE51C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ED8720-9E47-B5F5-4A82-E664167D6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A5E03-E4AF-490C-967C-814C2EF2C510}" type="datetimeFigureOut">
              <a:rPr lang="en-US" smtClean="0"/>
              <a:t>6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8D6650-3C2D-0E59-3D3F-8D6D63787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21B4C6-1669-BA95-F39F-1EB1304E41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74560-31AB-4824-97E0-F92999A43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808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15A00FF-6450-AC78-62EF-1CF72A118A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E35408-974B-06CA-15F1-00DCF19444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7F4FEA-1AED-E89E-0F1E-B9899D6F3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A5E03-E4AF-490C-967C-814C2EF2C510}" type="datetimeFigureOut">
              <a:rPr lang="en-US" smtClean="0"/>
              <a:t>6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86D7D0-13A3-9BE9-5D09-8BC9FF42FD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70B598-0FD2-CC13-4551-5ABA742AC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74560-31AB-4824-97E0-F92999A43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189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47A868-8D45-7929-710E-3EA379F996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406BC0-1AE9-9AAB-1D96-CC7F64E22E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EACC28-13DE-6C00-0A98-E3E505B35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A5E03-E4AF-490C-967C-814C2EF2C510}" type="datetimeFigureOut">
              <a:rPr lang="en-US" smtClean="0"/>
              <a:t>6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6DD00F-1565-1E5A-B33F-90C104B74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9484AF-4673-E0A1-A54E-8847F01990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74560-31AB-4824-97E0-F92999A43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3605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9389FE-021F-73B0-8700-03DF8048BF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DD4037-7344-9034-42A6-F14A1B7D59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7865DA-7100-E883-C29C-1D1A10CEE0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A5E03-E4AF-490C-967C-814C2EF2C510}" type="datetimeFigureOut">
              <a:rPr lang="en-US" smtClean="0"/>
              <a:t>6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A4C605-3C68-5163-6C54-FF5ACAB31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86B40F-5A4B-A516-9B8B-3BAD14388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74560-31AB-4824-97E0-F92999A43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4093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6BDC9A-D888-D8E7-93AA-1D819D1E8E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7183C9-693B-C2D1-5DCA-6EE01BD8B9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DCC35A-CF5A-5880-5686-3F794451C7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09D6A5-6D64-F1C1-3E04-56B71B9F53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A5E03-E4AF-490C-967C-814C2EF2C510}" type="datetimeFigureOut">
              <a:rPr lang="en-US" smtClean="0"/>
              <a:t>6/2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342191-05AA-D46E-A2C8-D5F3D94F68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2EDBCD-7FD4-F4C3-8DD4-C6BF13007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74560-31AB-4824-97E0-F92999A43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3818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FF3803-D0AB-3D9A-D825-8C1E9EB534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669E09-9E49-2C34-6284-508A7B46DC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A47BD1-9BB6-F16A-22C3-8C92EC9A3E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A94CA8A-9904-AEBE-2AF9-AEE832C8C1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0B0F5E-C6C8-73E8-924A-5856A87D1FD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D399D9-352D-B66A-AF9A-292A6C6324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A5E03-E4AF-490C-967C-814C2EF2C510}" type="datetimeFigureOut">
              <a:rPr lang="en-US" smtClean="0"/>
              <a:t>6/2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918456D-6AD4-E6AC-1FCD-EA71A5C432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6C2D1B8-29C8-7977-26C4-A905E31E8D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74560-31AB-4824-97E0-F92999A43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489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22B58B-29BD-A08D-D563-A1CB0C70E0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D20DE7A-C2B6-C64B-A387-190973A041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A5E03-E4AF-490C-967C-814C2EF2C510}" type="datetimeFigureOut">
              <a:rPr lang="en-US" smtClean="0"/>
              <a:t>6/2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3EC003B-3F0F-002E-B350-FC6AA5607A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973DF0A-88ED-7367-7471-DE72AF168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74560-31AB-4824-97E0-F92999A43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392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74FFD8A-6848-6752-3368-1EFD3DED1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A5E03-E4AF-490C-967C-814C2EF2C510}" type="datetimeFigureOut">
              <a:rPr lang="en-US" smtClean="0"/>
              <a:t>6/2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69ABF29-4854-E7AA-C3F6-ECE84F3CC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E1CDD97-848B-55C6-4C2D-4FCB5CFCC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74560-31AB-4824-97E0-F92999A43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188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144687-2A63-2AD0-FC90-907541B86C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E5C855-FEA6-95BF-4B3D-589AE971F7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687474-3D28-22D4-4E67-B6C9315212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4DCE9B-191F-F24C-AB5D-58FB43DFCE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A5E03-E4AF-490C-967C-814C2EF2C510}" type="datetimeFigureOut">
              <a:rPr lang="en-US" smtClean="0"/>
              <a:t>6/2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5F6E8C-6C60-94AA-DF8E-9866262CC9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76C615-AB0C-9E6A-53F4-8B678A82A3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74560-31AB-4824-97E0-F92999A43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334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A0CDA5-F796-FD3C-AD46-D62D1A5038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7978BC9-9477-2915-400E-285AAA19FE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35FFE8-6434-7E1A-D946-2183BAC93A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A535B4-B2BB-4FE1-8569-6A5CEFF12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A5E03-E4AF-490C-967C-814C2EF2C510}" type="datetimeFigureOut">
              <a:rPr lang="en-US" smtClean="0"/>
              <a:t>6/2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4A61B1-CD61-FBF6-88EB-34C38D9F7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E823E4-86CA-83DB-0DFE-5D13FFF13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74560-31AB-4824-97E0-F92999A43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7501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5464190-A314-99F6-154F-AB149FCE6D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F2C81F-B906-FC21-9687-C57747A6DE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F479D6-1FEC-5AE2-B92A-8F57011E96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CCA5E03-E4AF-490C-967C-814C2EF2C510}" type="datetimeFigureOut">
              <a:rPr lang="en-US" smtClean="0"/>
              <a:t>6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A455A9-5C30-F035-08CE-728B2C1C3B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7A83DB-50A9-5020-F216-A0265249CA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374560-31AB-4824-97E0-F92999A43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5915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7" Type="http://schemas.openxmlformats.org/officeDocument/2006/relationships/image" Target="../media/image9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jpg"/><Relationship Id="rId5" Type="http://schemas.openxmlformats.org/officeDocument/2006/relationships/image" Target="../media/image7.jpg"/><Relationship Id="rId4" Type="http://schemas.openxmlformats.org/officeDocument/2006/relationships/image" Target="../media/image6.jp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jpg"/><Relationship Id="rId4" Type="http://schemas.openxmlformats.org/officeDocument/2006/relationships/image" Target="../media/image12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C77298-FFC4-6807-06CA-DCCE1D2FB9E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materials </a:t>
            </a:r>
            <a:b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b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b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otato consumption and risk of type 2 diabetes mellitus: a harmonized  analysis of seven prospective cohorts</a:t>
            </a:r>
            <a:b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DF94A33-8611-F2EE-6086-3AE992216879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ead author: Luc Djousse</a:t>
            </a:r>
          </a:p>
        </p:txBody>
      </p:sp>
    </p:spTree>
    <p:extLst>
      <p:ext uri="{BB962C8B-B14F-4D97-AF65-F5344CB8AC3E}">
        <p14:creationId xmlns:p14="http://schemas.microsoft.com/office/powerpoint/2010/main" val="49163723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06D1FA37-8EA9-E33A-6A30-9A2EFB39F639}"/>
              </a:ext>
            </a:extLst>
          </p:cNvPr>
          <p:cNvSpPr txBox="1"/>
          <p:nvPr/>
        </p:nvSpPr>
        <p:spPr>
          <a:xfrm>
            <a:off x="439993" y="607278"/>
            <a:ext cx="1798320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: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0.5-1 serving/week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AF10DA1-C8F1-BF14-E305-D7F8E93D7060}"/>
              </a:ext>
            </a:extLst>
          </p:cNvPr>
          <p:cNvSpPr txBox="1"/>
          <p:nvPr/>
        </p:nvSpPr>
        <p:spPr>
          <a:xfrm>
            <a:off x="6567276" y="607278"/>
            <a:ext cx="1962572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: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&gt;1 to 3 servings/week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1C98B73-42C3-3C8B-26D3-89A2CE792BCA}"/>
              </a:ext>
            </a:extLst>
          </p:cNvPr>
          <p:cNvSpPr txBox="1"/>
          <p:nvPr/>
        </p:nvSpPr>
        <p:spPr>
          <a:xfrm>
            <a:off x="294639" y="107141"/>
            <a:ext cx="115925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Adjusted hazard ratios comparing levels of baked, boiled, mashed potato consumption to non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8094315-D5CE-B016-AA1D-F83E66B1ED58}"/>
              </a:ext>
            </a:extLst>
          </p:cNvPr>
          <p:cNvSpPr txBox="1"/>
          <p:nvPr/>
        </p:nvSpPr>
        <p:spPr>
          <a:xfrm>
            <a:off x="439993" y="3765501"/>
            <a:ext cx="1962572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: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&gt; 3 servings/week</a:t>
            </a:r>
          </a:p>
        </p:txBody>
      </p:sp>
      <p:pic>
        <p:nvPicPr>
          <p:cNvPr id="3" name="Picture 2" descr="A graph of a hazard model&#10;&#10;Description automatically generated with medium confidence">
            <a:extLst>
              <a:ext uri="{FF2B5EF4-FFF2-40B4-BE49-F238E27FC236}">
                <a16:creationId xmlns:a16="http://schemas.microsoft.com/office/drawing/2014/main" id="{B70A7F29-637A-3DAF-8EC1-B87C17354F2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379"/>
          <a:stretch/>
        </p:blipFill>
        <p:spPr>
          <a:xfrm>
            <a:off x="439994" y="978364"/>
            <a:ext cx="4877251" cy="2413150"/>
          </a:xfrm>
          <a:prstGeom prst="rect">
            <a:avLst/>
          </a:prstGeom>
        </p:spPr>
      </p:pic>
      <p:pic>
        <p:nvPicPr>
          <p:cNvPr id="5" name="Picture 4" descr="A graph of a number of numbers&#10;&#10;Description automatically generated with medium confidence">
            <a:extLst>
              <a:ext uri="{FF2B5EF4-FFF2-40B4-BE49-F238E27FC236}">
                <a16:creationId xmlns:a16="http://schemas.microsoft.com/office/drawing/2014/main" id="{54D71AF4-A996-3DFA-D96D-F039F5B815E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391"/>
          <a:stretch/>
        </p:blipFill>
        <p:spPr>
          <a:xfrm>
            <a:off x="6567276" y="978364"/>
            <a:ext cx="4877963" cy="2450636"/>
          </a:xfrm>
          <a:prstGeom prst="rect">
            <a:avLst/>
          </a:prstGeom>
        </p:spPr>
      </p:pic>
      <p:pic>
        <p:nvPicPr>
          <p:cNvPr id="9" name="Picture 8" descr="A graph of a hazard model&#10;&#10;Description automatically generated with medium confidence">
            <a:extLst>
              <a:ext uri="{FF2B5EF4-FFF2-40B4-BE49-F238E27FC236}">
                <a16:creationId xmlns:a16="http://schemas.microsoft.com/office/drawing/2014/main" id="{70F2371E-6FE7-BFBA-3007-000E8093A26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812"/>
          <a:stretch/>
        </p:blipFill>
        <p:spPr>
          <a:xfrm>
            <a:off x="439993" y="4074492"/>
            <a:ext cx="4877251" cy="2413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77938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716896E9-3CCD-93FD-7B16-D34CEE12D10F}"/>
              </a:ext>
            </a:extLst>
          </p:cNvPr>
          <p:cNvSpPr txBox="1"/>
          <p:nvPr/>
        </p:nvSpPr>
        <p:spPr>
          <a:xfrm>
            <a:off x="4338511" y="698451"/>
            <a:ext cx="40201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anel A: &gt;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1 fried potatoes/week vs. non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354E32F-96C2-DFFB-A0F1-3FF1214E11C5}"/>
              </a:ext>
            </a:extLst>
          </p:cNvPr>
          <p:cNvSpPr txBox="1"/>
          <p:nvPr/>
        </p:nvSpPr>
        <p:spPr>
          <a:xfrm>
            <a:off x="4338511" y="3730561"/>
            <a:ext cx="49537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anel B:  &gt;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0 and 1 fried potatoes/week vs. non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2E622E0-FA04-99D9-F3D5-F4C8211BCCA3}"/>
              </a:ext>
            </a:extLst>
          </p:cNvPr>
          <p:cNvSpPr txBox="1"/>
          <p:nvPr/>
        </p:nvSpPr>
        <p:spPr>
          <a:xfrm>
            <a:off x="267909" y="256674"/>
            <a:ext cx="114136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Omitting 1 study at a time and Galbraith plots for fried potato intake and T2D risk</a:t>
            </a:r>
          </a:p>
        </p:txBody>
      </p:sp>
      <p:pic>
        <p:nvPicPr>
          <p:cNvPr id="3" name="Picture 2" descr="A graph with numbers and a line&#10;&#10;Description automatically generated with medium confidence">
            <a:extLst>
              <a:ext uri="{FF2B5EF4-FFF2-40B4-BE49-F238E27FC236}">
                <a16:creationId xmlns:a16="http://schemas.microsoft.com/office/drawing/2014/main" id="{968B5997-7138-254F-EC3C-DB90A91377F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33" b="6379"/>
          <a:stretch/>
        </p:blipFill>
        <p:spPr>
          <a:xfrm>
            <a:off x="144379" y="1067783"/>
            <a:ext cx="4276660" cy="2760276"/>
          </a:xfrm>
          <a:prstGeom prst="rect">
            <a:avLst/>
          </a:prstGeom>
        </p:spPr>
      </p:pic>
      <p:pic>
        <p:nvPicPr>
          <p:cNvPr id="5" name="Picture 4" descr="A graph of a number of objects&#10;&#10;Description automatically generated with medium confidence">
            <a:extLst>
              <a:ext uri="{FF2B5EF4-FFF2-40B4-BE49-F238E27FC236}">
                <a16:creationId xmlns:a16="http://schemas.microsoft.com/office/drawing/2014/main" id="{C02B4DAF-35EC-545C-0F61-E50836ACAEC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29" b="9141"/>
          <a:stretch/>
        </p:blipFill>
        <p:spPr>
          <a:xfrm>
            <a:off x="4591811" y="1137341"/>
            <a:ext cx="3513539" cy="2501434"/>
          </a:xfrm>
          <a:prstGeom prst="rect">
            <a:avLst/>
          </a:prstGeom>
        </p:spPr>
      </p:pic>
      <p:pic>
        <p:nvPicPr>
          <p:cNvPr id="8" name="Picture 7" descr="A graph showing the results of a linear plot&#10;&#10;Description automatically generated with medium confidence">
            <a:extLst>
              <a:ext uri="{FF2B5EF4-FFF2-40B4-BE49-F238E27FC236}">
                <a16:creationId xmlns:a16="http://schemas.microsoft.com/office/drawing/2014/main" id="{9486AAFD-5146-4F77-A521-59115695773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60" b="2960"/>
          <a:stretch/>
        </p:blipFill>
        <p:spPr>
          <a:xfrm>
            <a:off x="8267946" y="1270924"/>
            <a:ext cx="3450788" cy="2158076"/>
          </a:xfrm>
          <a:prstGeom prst="rect">
            <a:avLst/>
          </a:prstGeom>
        </p:spPr>
      </p:pic>
      <p:pic>
        <p:nvPicPr>
          <p:cNvPr id="10" name="Picture 9" descr="A graph of a number of numbers&#10;&#10;Description automatically generated with medium confidence">
            <a:extLst>
              <a:ext uri="{FF2B5EF4-FFF2-40B4-BE49-F238E27FC236}">
                <a16:creationId xmlns:a16="http://schemas.microsoft.com/office/drawing/2014/main" id="{CA9C7866-2442-81EF-5196-93200A4C523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66" b="6379"/>
          <a:stretch/>
        </p:blipFill>
        <p:spPr>
          <a:xfrm>
            <a:off x="188583" y="4129618"/>
            <a:ext cx="4149928" cy="2650187"/>
          </a:xfrm>
          <a:prstGeom prst="rect">
            <a:avLst/>
          </a:prstGeom>
        </p:spPr>
      </p:pic>
      <p:pic>
        <p:nvPicPr>
          <p:cNvPr id="14" name="Picture 13" descr="A graph of a number of individuals&#10;&#10;Description automatically generated with medium confidence">
            <a:extLst>
              <a:ext uri="{FF2B5EF4-FFF2-40B4-BE49-F238E27FC236}">
                <a16:creationId xmlns:a16="http://schemas.microsoft.com/office/drawing/2014/main" id="{C24EE497-61B6-AFEE-00BE-CAFD695D384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56" b="7201"/>
          <a:stretch/>
        </p:blipFill>
        <p:spPr>
          <a:xfrm>
            <a:off x="4591811" y="4250743"/>
            <a:ext cx="3513539" cy="2407936"/>
          </a:xfrm>
          <a:prstGeom prst="rect">
            <a:avLst/>
          </a:prstGeom>
        </p:spPr>
      </p:pic>
      <p:pic>
        <p:nvPicPr>
          <p:cNvPr id="20" name="Picture 19" descr="A graph showing the results of a linear plot&#10;&#10;Description automatically generated with medium confidence">
            <a:extLst>
              <a:ext uri="{FF2B5EF4-FFF2-40B4-BE49-F238E27FC236}">
                <a16:creationId xmlns:a16="http://schemas.microsoft.com/office/drawing/2014/main" id="{65C18113-26DA-4137-9C6D-0295B2AFEB3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02" b="3180"/>
          <a:stretch/>
        </p:blipFill>
        <p:spPr>
          <a:xfrm>
            <a:off x="8267946" y="4250743"/>
            <a:ext cx="3450788" cy="21500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643026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06D1FA37-8EA9-E33A-6A30-9A2EFB39F639}"/>
              </a:ext>
            </a:extLst>
          </p:cNvPr>
          <p:cNvSpPr txBox="1"/>
          <p:nvPr/>
        </p:nvSpPr>
        <p:spPr>
          <a:xfrm>
            <a:off x="3337888" y="720811"/>
            <a:ext cx="1798320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: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&gt;0 to 1 serving/week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AF10DA1-C8F1-BF14-E305-D7F8E93D7060}"/>
              </a:ext>
            </a:extLst>
          </p:cNvPr>
          <p:cNvSpPr txBox="1"/>
          <p:nvPr/>
        </p:nvSpPr>
        <p:spPr>
          <a:xfrm>
            <a:off x="9151383" y="720811"/>
            <a:ext cx="1962572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: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&gt; 1 servings/week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1C98B73-42C3-3C8B-26D3-89A2CE792BCA}"/>
              </a:ext>
            </a:extLst>
          </p:cNvPr>
          <p:cNvSpPr txBox="1"/>
          <p:nvPr/>
        </p:nvSpPr>
        <p:spPr>
          <a:xfrm>
            <a:off x="294640" y="163697"/>
            <a:ext cx="116027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djusted hazard ratios comparing levels of fried potato consumption to none by BMI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810BF90-CF1B-8F01-F449-B3579250E716}"/>
              </a:ext>
            </a:extLst>
          </p:cNvPr>
          <p:cNvSpPr txBox="1"/>
          <p:nvPr/>
        </p:nvSpPr>
        <p:spPr>
          <a:xfrm>
            <a:off x="345441" y="2157313"/>
            <a:ext cx="1189848" cy="26161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MI &lt; 25 kg/m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B69D9A1-E74A-BABC-3C55-1E5BE4210412}"/>
              </a:ext>
            </a:extLst>
          </p:cNvPr>
          <p:cNvSpPr txBox="1"/>
          <p:nvPr/>
        </p:nvSpPr>
        <p:spPr>
          <a:xfrm>
            <a:off x="294640" y="5017057"/>
            <a:ext cx="1321928" cy="261610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MI ≥ 25 kg/m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A graph of a hazard model&#10;&#10;Description automatically generated with medium confidence">
            <a:extLst>
              <a:ext uri="{FF2B5EF4-FFF2-40B4-BE49-F238E27FC236}">
                <a16:creationId xmlns:a16="http://schemas.microsoft.com/office/drawing/2014/main" id="{DA2A1CA1-2D21-96D3-1CF1-58120344950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140"/>
          <a:stretch/>
        </p:blipFill>
        <p:spPr>
          <a:xfrm>
            <a:off x="1818640" y="1196628"/>
            <a:ext cx="4693919" cy="2501613"/>
          </a:xfrm>
          <a:prstGeom prst="rect">
            <a:avLst/>
          </a:prstGeom>
        </p:spPr>
      </p:pic>
      <p:pic>
        <p:nvPicPr>
          <p:cNvPr id="12" name="Picture 11" descr="A graph of a hazard model&#10;&#10;Description automatically generated with medium confidence">
            <a:extLst>
              <a:ext uri="{FF2B5EF4-FFF2-40B4-BE49-F238E27FC236}">
                <a16:creationId xmlns:a16="http://schemas.microsoft.com/office/drawing/2014/main" id="{F2CCA9A9-F163-8B86-7A80-43651ED01BC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140"/>
          <a:stretch/>
        </p:blipFill>
        <p:spPr>
          <a:xfrm>
            <a:off x="7376157" y="1196628"/>
            <a:ext cx="4521201" cy="2501613"/>
          </a:xfrm>
          <a:prstGeom prst="rect">
            <a:avLst/>
          </a:prstGeom>
        </p:spPr>
      </p:pic>
      <p:pic>
        <p:nvPicPr>
          <p:cNvPr id="16" name="Picture 15" descr="A graph of a number of individuals&#10;&#10;Description automatically generated with medium confidence">
            <a:extLst>
              <a:ext uri="{FF2B5EF4-FFF2-40B4-BE49-F238E27FC236}">
                <a16:creationId xmlns:a16="http://schemas.microsoft.com/office/drawing/2014/main" id="{023F9EA5-0CD8-BF49-29F0-E82DAEBE016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514"/>
          <a:stretch/>
        </p:blipFill>
        <p:spPr>
          <a:xfrm>
            <a:off x="1818640" y="4356386"/>
            <a:ext cx="4693919" cy="2161259"/>
          </a:xfrm>
          <a:prstGeom prst="rect">
            <a:avLst/>
          </a:prstGeom>
        </p:spPr>
      </p:pic>
      <p:pic>
        <p:nvPicPr>
          <p:cNvPr id="18" name="Picture 17" descr="A graph of a number of individuals&#10;&#10;Description automatically generated with medium confidence">
            <a:extLst>
              <a:ext uri="{FF2B5EF4-FFF2-40B4-BE49-F238E27FC236}">
                <a16:creationId xmlns:a16="http://schemas.microsoft.com/office/drawing/2014/main" id="{9FD27FAF-A7E3-FA31-9DE8-C902838530C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514"/>
          <a:stretch/>
        </p:blipFill>
        <p:spPr>
          <a:xfrm>
            <a:off x="7376158" y="4356386"/>
            <a:ext cx="4521201" cy="21612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23478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EDF27B-9695-FE3B-2D5C-824733C8F1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05467" y="394230"/>
            <a:ext cx="9144000" cy="367770"/>
          </a:xfrm>
        </p:spPr>
        <p:txBody>
          <a:bodyPr>
            <a:no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low Chart a -- ARIC</a:t>
            </a:r>
          </a:p>
        </p:txBody>
      </p:sp>
      <p:sp>
        <p:nvSpPr>
          <p:cNvPr id="4" name="Text Box 2">
            <a:extLst>
              <a:ext uri="{FF2B5EF4-FFF2-40B4-BE49-F238E27FC236}">
                <a16:creationId xmlns:a16="http://schemas.microsoft.com/office/drawing/2014/main" id="{45C4B5CF-827A-8A5D-1B98-52882BB3DE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4713" y="1153160"/>
            <a:ext cx="2395220" cy="100584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umber of subjects at baseline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=15,792)</a:t>
            </a:r>
          </a:p>
        </p:txBody>
      </p:sp>
      <p:sp>
        <p:nvSpPr>
          <p:cNvPr id="5" name="Text Box 2">
            <a:extLst>
              <a:ext uri="{FF2B5EF4-FFF2-40B4-BE49-F238E27FC236}">
                <a16:creationId xmlns:a16="http://schemas.microsoft.com/office/drawing/2014/main" id="{C846FAAE-C9B5-5ADD-520E-5753374DD1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0913" y="4539827"/>
            <a:ext cx="2395220" cy="77724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nal sample included in current analyses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=15,106)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3CD738E2-2D7E-9A52-53DE-50FA5E11DC16}"/>
              </a:ext>
            </a:extLst>
          </p:cNvPr>
          <p:cNvCxnSpPr>
            <a:cxnSpLocks/>
            <a:stCxn id="4" idx="2"/>
          </p:cNvCxnSpPr>
          <p:nvPr/>
        </p:nvCxnSpPr>
        <p:spPr>
          <a:xfrm>
            <a:off x="6312323" y="2159000"/>
            <a:ext cx="0" cy="23808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7ADAAF35-CA3B-CB7C-DB9D-A8D457220A7B}"/>
              </a:ext>
            </a:extLst>
          </p:cNvPr>
          <p:cNvCxnSpPr>
            <a:cxnSpLocks/>
          </p:cNvCxnSpPr>
          <p:nvPr/>
        </p:nvCxnSpPr>
        <p:spPr>
          <a:xfrm>
            <a:off x="6312323" y="3258766"/>
            <a:ext cx="1382256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 Box 2">
            <a:extLst>
              <a:ext uri="{FF2B5EF4-FFF2-40B4-BE49-F238E27FC236}">
                <a16:creationId xmlns:a16="http://schemas.microsoft.com/office/drawing/2014/main" id="{1973A721-0973-97EF-1AFE-13D5ED478F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94579" y="2584153"/>
            <a:ext cx="3822970" cy="134922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cluded 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ue to: 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evalent diabetes (n=176)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ssing data on potato consumption (n=376)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treme caloric intake (n=298)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oss to follow up (n=128)</a:t>
            </a:r>
            <a:endParaRPr lang="en-US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32745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EDF27B-9695-FE3B-2D5C-824733C8F1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05467" y="394230"/>
            <a:ext cx="9144000" cy="367770"/>
          </a:xfrm>
        </p:spPr>
        <p:txBody>
          <a:bodyPr>
            <a:no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low Chart b -- CARDIA</a:t>
            </a:r>
          </a:p>
        </p:txBody>
      </p:sp>
      <p:sp>
        <p:nvSpPr>
          <p:cNvPr id="4" name="Text Box 2">
            <a:extLst>
              <a:ext uri="{FF2B5EF4-FFF2-40B4-BE49-F238E27FC236}">
                <a16:creationId xmlns:a16="http://schemas.microsoft.com/office/drawing/2014/main" id="{45C4B5CF-827A-8A5D-1B98-52882BB3DE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4713" y="1153160"/>
            <a:ext cx="2395220" cy="100584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umber of subjects at baseline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=5,115)</a:t>
            </a:r>
          </a:p>
        </p:txBody>
      </p:sp>
      <p:sp>
        <p:nvSpPr>
          <p:cNvPr id="5" name="Text Box 2">
            <a:extLst>
              <a:ext uri="{FF2B5EF4-FFF2-40B4-BE49-F238E27FC236}">
                <a16:creationId xmlns:a16="http://schemas.microsoft.com/office/drawing/2014/main" id="{C846FAAE-C9B5-5ADD-520E-5753374DD1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0913" y="4539827"/>
            <a:ext cx="2395220" cy="77724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nal sample included in current analyses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=4,042)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3CD738E2-2D7E-9A52-53DE-50FA5E11DC16}"/>
              </a:ext>
            </a:extLst>
          </p:cNvPr>
          <p:cNvCxnSpPr>
            <a:cxnSpLocks/>
            <a:stCxn id="4" idx="2"/>
          </p:cNvCxnSpPr>
          <p:nvPr/>
        </p:nvCxnSpPr>
        <p:spPr>
          <a:xfrm>
            <a:off x="6312323" y="2159000"/>
            <a:ext cx="0" cy="23808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7ADAAF35-CA3B-CB7C-DB9D-A8D457220A7B}"/>
              </a:ext>
            </a:extLst>
          </p:cNvPr>
          <p:cNvCxnSpPr>
            <a:cxnSpLocks/>
          </p:cNvCxnSpPr>
          <p:nvPr/>
        </p:nvCxnSpPr>
        <p:spPr>
          <a:xfrm>
            <a:off x="6312323" y="3258766"/>
            <a:ext cx="1382256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 Box 2">
            <a:extLst>
              <a:ext uri="{FF2B5EF4-FFF2-40B4-BE49-F238E27FC236}">
                <a16:creationId xmlns:a16="http://schemas.microsoft.com/office/drawing/2014/main" id="{1973A721-0973-97EF-1AFE-13D5ED478F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94579" y="2584153"/>
            <a:ext cx="3822970" cy="134922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cluded 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ue to: 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evalent diabetes (n=34)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ssing data on potato consumption (n=0)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treme caloric intake (n=49)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oss to follow up (n=1,052)</a:t>
            </a:r>
            <a:endParaRPr lang="en-US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62491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EDF27B-9695-FE3B-2D5C-824733C8F1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05467" y="394230"/>
            <a:ext cx="9144000" cy="367770"/>
          </a:xfrm>
        </p:spPr>
        <p:txBody>
          <a:bodyPr>
            <a:no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low Chart c -- COSMOS</a:t>
            </a:r>
          </a:p>
        </p:txBody>
      </p:sp>
      <p:sp>
        <p:nvSpPr>
          <p:cNvPr id="4" name="Text Box 2">
            <a:extLst>
              <a:ext uri="{FF2B5EF4-FFF2-40B4-BE49-F238E27FC236}">
                <a16:creationId xmlns:a16="http://schemas.microsoft.com/office/drawing/2014/main" id="{45C4B5CF-827A-8A5D-1B98-52882BB3DE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4713" y="1153160"/>
            <a:ext cx="2395220" cy="100584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umber of subjects at baseline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=21,063)</a:t>
            </a:r>
          </a:p>
        </p:txBody>
      </p:sp>
      <p:sp>
        <p:nvSpPr>
          <p:cNvPr id="5" name="Text Box 2">
            <a:extLst>
              <a:ext uri="{FF2B5EF4-FFF2-40B4-BE49-F238E27FC236}">
                <a16:creationId xmlns:a16="http://schemas.microsoft.com/office/drawing/2014/main" id="{C846FAAE-C9B5-5ADD-520E-5753374DD1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0913" y="4539827"/>
            <a:ext cx="2395220" cy="77724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nal sample included in current analyses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=16,808)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3CD738E2-2D7E-9A52-53DE-50FA5E11DC16}"/>
              </a:ext>
            </a:extLst>
          </p:cNvPr>
          <p:cNvCxnSpPr>
            <a:cxnSpLocks/>
            <a:stCxn id="4" idx="2"/>
          </p:cNvCxnSpPr>
          <p:nvPr/>
        </p:nvCxnSpPr>
        <p:spPr>
          <a:xfrm>
            <a:off x="6312323" y="2159000"/>
            <a:ext cx="0" cy="23808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7ADAAF35-CA3B-CB7C-DB9D-A8D457220A7B}"/>
              </a:ext>
            </a:extLst>
          </p:cNvPr>
          <p:cNvCxnSpPr>
            <a:cxnSpLocks/>
          </p:cNvCxnSpPr>
          <p:nvPr/>
        </p:nvCxnSpPr>
        <p:spPr>
          <a:xfrm>
            <a:off x="6312323" y="3258766"/>
            <a:ext cx="1382256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 Box 2">
            <a:extLst>
              <a:ext uri="{FF2B5EF4-FFF2-40B4-BE49-F238E27FC236}">
                <a16:creationId xmlns:a16="http://schemas.microsoft.com/office/drawing/2014/main" id="{1973A721-0973-97EF-1AFE-13D5ED478F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94579" y="2584153"/>
            <a:ext cx="3822970" cy="134922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cluded 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ue to: 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evalent diabetes (n=2,989)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ssing data on potato consumption (n=959)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treme caloric intake (n=307)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oss to follow up (n=0)</a:t>
            </a:r>
            <a:endParaRPr lang="en-US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79090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EDF27B-9695-FE3B-2D5C-824733C8F1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05467" y="394230"/>
            <a:ext cx="9144000" cy="367770"/>
          </a:xfrm>
        </p:spPr>
        <p:txBody>
          <a:bodyPr>
            <a:no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low Chart d -- MESA</a:t>
            </a:r>
          </a:p>
        </p:txBody>
      </p:sp>
      <p:sp>
        <p:nvSpPr>
          <p:cNvPr id="4" name="Text Box 2">
            <a:extLst>
              <a:ext uri="{FF2B5EF4-FFF2-40B4-BE49-F238E27FC236}">
                <a16:creationId xmlns:a16="http://schemas.microsoft.com/office/drawing/2014/main" id="{45C4B5CF-827A-8A5D-1B98-52882BB3DE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4713" y="1153160"/>
            <a:ext cx="2395220" cy="100584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umber of subjects at baseline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=6,814)</a:t>
            </a:r>
          </a:p>
        </p:txBody>
      </p:sp>
      <p:sp>
        <p:nvSpPr>
          <p:cNvPr id="5" name="Text Box 2">
            <a:extLst>
              <a:ext uri="{FF2B5EF4-FFF2-40B4-BE49-F238E27FC236}">
                <a16:creationId xmlns:a16="http://schemas.microsoft.com/office/drawing/2014/main" id="{C846FAAE-C9B5-5ADD-520E-5753374DD1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0913" y="4539827"/>
            <a:ext cx="2395220" cy="77724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nal sample included in current analyses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=5,417)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3CD738E2-2D7E-9A52-53DE-50FA5E11DC16}"/>
              </a:ext>
            </a:extLst>
          </p:cNvPr>
          <p:cNvCxnSpPr>
            <a:cxnSpLocks/>
            <a:stCxn id="4" idx="2"/>
          </p:cNvCxnSpPr>
          <p:nvPr/>
        </p:nvCxnSpPr>
        <p:spPr>
          <a:xfrm>
            <a:off x="6312323" y="2159000"/>
            <a:ext cx="0" cy="23808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7ADAAF35-CA3B-CB7C-DB9D-A8D457220A7B}"/>
              </a:ext>
            </a:extLst>
          </p:cNvPr>
          <p:cNvCxnSpPr>
            <a:cxnSpLocks/>
          </p:cNvCxnSpPr>
          <p:nvPr/>
        </p:nvCxnSpPr>
        <p:spPr>
          <a:xfrm>
            <a:off x="6312323" y="3258766"/>
            <a:ext cx="1382256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 Box 2">
            <a:extLst>
              <a:ext uri="{FF2B5EF4-FFF2-40B4-BE49-F238E27FC236}">
                <a16:creationId xmlns:a16="http://schemas.microsoft.com/office/drawing/2014/main" id="{1973A721-0973-97EF-1AFE-13D5ED478F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94579" y="2584153"/>
            <a:ext cx="3822970" cy="134922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cluded 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ue to: 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evalent diabetes (n=796)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ssing data on potato consumption (n=283)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treme caloric intake (n=316)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oss to follow up (n=2)</a:t>
            </a:r>
            <a:endParaRPr lang="en-US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01581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EDF27B-9695-FE3B-2D5C-824733C8F1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05467" y="394230"/>
            <a:ext cx="9144000" cy="367770"/>
          </a:xfrm>
        </p:spPr>
        <p:txBody>
          <a:bodyPr>
            <a:no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low Chart e -- PHS</a:t>
            </a:r>
          </a:p>
        </p:txBody>
      </p:sp>
      <p:sp>
        <p:nvSpPr>
          <p:cNvPr id="4" name="Text Box 2">
            <a:extLst>
              <a:ext uri="{FF2B5EF4-FFF2-40B4-BE49-F238E27FC236}">
                <a16:creationId xmlns:a16="http://schemas.microsoft.com/office/drawing/2014/main" id="{45C4B5CF-827A-8A5D-1B98-52882BB3DE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4713" y="1153160"/>
            <a:ext cx="2395220" cy="100584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umber of subjects at baseline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=21,075)</a:t>
            </a:r>
          </a:p>
        </p:txBody>
      </p:sp>
      <p:sp>
        <p:nvSpPr>
          <p:cNvPr id="5" name="Text Box 2">
            <a:extLst>
              <a:ext uri="{FF2B5EF4-FFF2-40B4-BE49-F238E27FC236}">
                <a16:creationId xmlns:a16="http://schemas.microsoft.com/office/drawing/2014/main" id="{C846FAAE-C9B5-5ADD-520E-5753374DD1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0913" y="4539827"/>
            <a:ext cx="2395220" cy="77724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nal sample included in current analyses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=19,472)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3CD738E2-2D7E-9A52-53DE-50FA5E11DC16}"/>
              </a:ext>
            </a:extLst>
          </p:cNvPr>
          <p:cNvCxnSpPr>
            <a:cxnSpLocks/>
            <a:stCxn id="4" idx="2"/>
          </p:cNvCxnSpPr>
          <p:nvPr/>
        </p:nvCxnSpPr>
        <p:spPr>
          <a:xfrm>
            <a:off x="6312323" y="2159000"/>
            <a:ext cx="0" cy="23808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7ADAAF35-CA3B-CB7C-DB9D-A8D457220A7B}"/>
              </a:ext>
            </a:extLst>
          </p:cNvPr>
          <p:cNvCxnSpPr>
            <a:cxnSpLocks/>
          </p:cNvCxnSpPr>
          <p:nvPr/>
        </p:nvCxnSpPr>
        <p:spPr>
          <a:xfrm>
            <a:off x="6312323" y="3258766"/>
            <a:ext cx="1382256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 Box 2">
            <a:extLst>
              <a:ext uri="{FF2B5EF4-FFF2-40B4-BE49-F238E27FC236}">
                <a16:creationId xmlns:a16="http://schemas.microsoft.com/office/drawing/2014/main" id="{1973A721-0973-97EF-1AFE-13D5ED478F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94579" y="2584153"/>
            <a:ext cx="3822970" cy="134922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cluded 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ue to: 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evalent diabetes (n=1,603)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ssing data on potato consumption (n=0) 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oss to follow up (n=0)</a:t>
            </a:r>
            <a:endParaRPr lang="en-US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7081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EDF27B-9695-FE3B-2D5C-824733C8F1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05467" y="394230"/>
            <a:ext cx="9144000" cy="367770"/>
          </a:xfrm>
        </p:spPr>
        <p:txBody>
          <a:bodyPr>
            <a:no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low Chart f -- WACS</a:t>
            </a:r>
          </a:p>
        </p:txBody>
      </p:sp>
      <p:sp>
        <p:nvSpPr>
          <p:cNvPr id="4" name="Text Box 2">
            <a:extLst>
              <a:ext uri="{FF2B5EF4-FFF2-40B4-BE49-F238E27FC236}">
                <a16:creationId xmlns:a16="http://schemas.microsoft.com/office/drawing/2014/main" id="{45C4B5CF-827A-8A5D-1B98-52882BB3DE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4713" y="1153160"/>
            <a:ext cx="2395220" cy="100584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umber of subjects at baseline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=8,075)</a:t>
            </a:r>
          </a:p>
        </p:txBody>
      </p:sp>
      <p:sp>
        <p:nvSpPr>
          <p:cNvPr id="5" name="Text Box 2">
            <a:extLst>
              <a:ext uri="{FF2B5EF4-FFF2-40B4-BE49-F238E27FC236}">
                <a16:creationId xmlns:a16="http://schemas.microsoft.com/office/drawing/2014/main" id="{C846FAAE-C9B5-5ADD-520E-5753374DD1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0913" y="4539827"/>
            <a:ext cx="2395220" cy="77724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nal sample included in current analyses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=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6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500)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3CD738E2-2D7E-9A52-53DE-50FA5E11DC16}"/>
              </a:ext>
            </a:extLst>
          </p:cNvPr>
          <p:cNvCxnSpPr>
            <a:cxnSpLocks/>
            <a:stCxn id="4" idx="2"/>
          </p:cNvCxnSpPr>
          <p:nvPr/>
        </p:nvCxnSpPr>
        <p:spPr>
          <a:xfrm>
            <a:off x="6312323" y="2159000"/>
            <a:ext cx="0" cy="23808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7ADAAF35-CA3B-CB7C-DB9D-A8D457220A7B}"/>
              </a:ext>
            </a:extLst>
          </p:cNvPr>
          <p:cNvCxnSpPr>
            <a:cxnSpLocks/>
          </p:cNvCxnSpPr>
          <p:nvPr/>
        </p:nvCxnSpPr>
        <p:spPr>
          <a:xfrm>
            <a:off x="6312323" y="3258766"/>
            <a:ext cx="1382256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 Box 2">
            <a:extLst>
              <a:ext uri="{FF2B5EF4-FFF2-40B4-BE49-F238E27FC236}">
                <a16:creationId xmlns:a16="http://schemas.microsoft.com/office/drawing/2014/main" id="{1973A721-0973-97EF-1AFE-13D5ED478F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94579" y="2584153"/>
            <a:ext cx="3822970" cy="134922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cluded 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ue to: 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evalent diabetes (n=1,575)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ssing data on potato consumption (n=0) 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oss to follow up (n=0)</a:t>
            </a:r>
            <a:endParaRPr lang="en-US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31302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EDF27B-9695-FE3B-2D5C-824733C8F1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05467" y="394230"/>
            <a:ext cx="9144000" cy="367770"/>
          </a:xfrm>
        </p:spPr>
        <p:txBody>
          <a:bodyPr>
            <a:no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low </a:t>
            </a:r>
            <a:r>
              <a:rPr lang="en-US" sz="2400">
                <a:latin typeface="Arial" panose="020B0604020202020204" pitchFamily="34" charset="0"/>
                <a:cs typeface="Arial" panose="020B0604020202020204" pitchFamily="34" charset="0"/>
              </a:rPr>
              <a:t>Chart g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-- WHS</a:t>
            </a:r>
          </a:p>
        </p:txBody>
      </p:sp>
      <p:sp>
        <p:nvSpPr>
          <p:cNvPr id="4" name="Text Box 2">
            <a:extLst>
              <a:ext uri="{FF2B5EF4-FFF2-40B4-BE49-F238E27FC236}">
                <a16:creationId xmlns:a16="http://schemas.microsoft.com/office/drawing/2014/main" id="{45C4B5CF-827A-8A5D-1B98-52882BB3DE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4713" y="1153160"/>
            <a:ext cx="2395220" cy="100584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umber of subjects at baseline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=39,634)</a:t>
            </a:r>
          </a:p>
        </p:txBody>
      </p:sp>
      <p:sp>
        <p:nvSpPr>
          <p:cNvPr id="5" name="Text Box 2">
            <a:extLst>
              <a:ext uri="{FF2B5EF4-FFF2-40B4-BE49-F238E27FC236}">
                <a16:creationId xmlns:a16="http://schemas.microsoft.com/office/drawing/2014/main" id="{C846FAAE-C9B5-5ADD-520E-5753374DD1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0913" y="4539827"/>
            <a:ext cx="2395220" cy="77724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nal sample included in current analyses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=38,186)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3CD738E2-2D7E-9A52-53DE-50FA5E11DC16}"/>
              </a:ext>
            </a:extLst>
          </p:cNvPr>
          <p:cNvCxnSpPr>
            <a:cxnSpLocks/>
            <a:stCxn id="4" idx="2"/>
          </p:cNvCxnSpPr>
          <p:nvPr/>
        </p:nvCxnSpPr>
        <p:spPr>
          <a:xfrm>
            <a:off x="6312323" y="2159000"/>
            <a:ext cx="0" cy="23808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7ADAAF35-CA3B-CB7C-DB9D-A8D457220A7B}"/>
              </a:ext>
            </a:extLst>
          </p:cNvPr>
          <p:cNvCxnSpPr>
            <a:cxnSpLocks/>
          </p:cNvCxnSpPr>
          <p:nvPr/>
        </p:nvCxnSpPr>
        <p:spPr>
          <a:xfrm>
            <a:off x="6312323" y="3258766"/>
            <a:ext cx="1382256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 Box 2">
            <a:extLst>
              <a:ext uri="{FF2B5EF4-FFF2-40B4-BE49-F238E27FC236}">
                <a16:creationId xmlns:a16="http://schemas.microsoft.com/office/drawing/2014/main" id="{1973A721-0973-97EF-1AFE-13D5ED478F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94579" y="2584153"/>
            <a:ext cx="3822970" cy="134922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cluded 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ue to: 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evalent diabetes (n=1,131)</a:t>
            </a: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ssing data on potato consumption (n=317)</a:t>
            </a:r>
            <a:endParaRPr lang="en-US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400050" marR="0" indent="-400050">
              <a:spcBef>
                <a:spcPts val="0"/>
              </a:spcBef>
              <a:spcAft>
                <a:spcPts val="0"/>
              </a:spcAft>
              <a:buAutoNum type="romanLcParenBoth"/>
            </a:pP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oss to follow up (n=0)</a:t>
            </a:r>
            <a:endParaRPr lang="en-US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825473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8A01D5-92B8-4A36-557E-1B15049DF7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3065462"/>
          </a:xfrm>
        </p:spPr>
        <p:txBody>
          <a:bodyPr>
            <a:normAutofit fontScale="90000"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s</a:t>
            </a:r>
            <a:b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</a:br>
            <a:br>
              <a:rPr lang="en-US" sz="2400" u="sng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800" u="sng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s 1, 2, and 3: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b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azard ratios derived from Cox regression adjusting for age, sex, BMI, race, education, energy intake, smoking status, alcohol intake, physical activity, fruits and vegetables, red/processed meat, whole grain, sugar sweetened beverages, nuts/peanut butter, legumes, and trans fatty acids (when available).</a:t>
            </a:r>
            <a:b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</a:br>
            <a:b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</a:br>
            <a:b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</a:br>
            <a:b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</a:br>
            <a:b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5108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672</Words>
  <Application>Microsoft Office PowerPoint</Application>
  <PresentationFormat>Widescreen</PresentationFormat>
  <Paragraphs>82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ptos</vt:lpstr>
      <vt:lpstr>Aptos Display</vt:lpstr>
      <vt:lpstr>Arial</vt:lpstr>
      <vt:lpstr>Calibri</vt:lpstr>
      <vt:lpstr>Office Theme</vt:lpstr>
      <vt:lpstr>Supplemental materials    Potato consumption and risk of type 2 diabetes mellitus: a harmonized  analysis of seven prospective cohorts </vt:lpstr>
      <vt:lpstr>Supplemental Flow Chart a -- ARIC</vt:lpstr>
      <vt:lpstr>Supplemental Flow Chart b -- CARDIA</vt:lpstr>
      <vt:lpstr>Supplemental Flow Chart c -- COSMOS</vt:lpstr>
      <vt:lpstr>Supplemental Flow Chart d -- MESA</vt:lpstr>
      <vt:lpstr>Supplemental Flow Chart e -- PHS</vt:lpstr>
      <vt:lpstr>Supplemental Flow Chart f -- WACS</vt:lpstr>
      <vt:lpstr>Supplemental Flow Chart g -- WHS</vt:lpstr>
      <vt:lpstr>Supplemental Figures  Supplemental figures 1, 2, and 3:  Hazard ratios derived from Cox regression adjusting for age, sex, BMI, race, education, energy intake, smoking status, alcohol intake, physical activity, fruits and vegetables, red/processed meat, whole grain, sugar sweetened beverages, nuts/peanut butter, legumes, and trans fatty acids (when available).      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low Chart 3a -- ARIC</dc:title>
  <dc:creator>Djousse, Luc,M.D.,M.P.H.,Sc.D.</dc:creator>
  <cp:lastModifiedBy>Djousse, Luc,M.D.,M.P.H.,Sc.D.</cp:lastModifiedBy>
  <cp:revision>9</cp:revision>
  <dcterms:created xsi:type="dcterms:W3CDTF">2024-04-01T19:24:58Z</dcterms:created>
  <dcterms:modified xsi:type="dcterms:W3CDTF">2024-06-27T19:08:51Z</dcterms:modified>
</cp:coreProperties>
</file>